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33" userDrawn="1">
          <p15:clr>
            <a:srgbClr val="A4A3A4"/>
          </p15:clr>
        </p15:guide>
        <p15:guide id="2" pos="27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1290" y="72"/>
      </p:cViewPr>
      <p:guideLst>
        <p:guide orient="horz" pos="4133"/>
        <p:guide pos="2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854347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99631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8395028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958502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23781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720952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14421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697904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89635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85545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72238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55178-85B1-4D1D-A196-8F07CF6737FF}" type="datetimeFigureOut">
              <a:rPr lang="en-ZA" smtClean="0"/>
              <a:t>2017/04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27B7B-0617-4871-83A2-69FF855B4278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7042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476518" y="2356501"/>
            <a:ext cx="8190963" cy="1938992"/>
            <a:chOff x="1792306" y="1416343"/>
            <a:chExt cx="8190963" cy="1938992"/>
          </a:xfrm>
        </p:grpSpPr>
        <p:grpSp>
          <p:nvGrpSpPr>
            <p:cNvPr id="5" name="Group 4"/>
            <p:cNvGrpSpPr/>
            <p:nvPr/>
          </p:nvGrpSpPr>
          <p:grpSpPr>
            <a:xfrm>
              <a:off x="3738119" y="2035095"/>
              <a:ext cx="6245150" cy="842606"/>
              <a:chOff x="3738119" y="2035095"/>
              <a:chExt cx="6245150" cy="842606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7867885" y="2340233"/>
                <a:ext cx="1857375" cy="215444"/>
                <a:chOff x="7077075" y="904538"/>
                <a:chExt cx="2358660" cy="222454"/>
              </a:xfrm>
            </p:grpSpPr>
            <p:sp>
              <p:nvSpPr>
                <p:cNvPr id="35" name="Rounded Rectangle 34"/>
                <p:cNvSpPr/>
                <p:nvPr/>
              </p:nvSpPr>
              <p:spPr>
                <a:xfrm>
                  <a:off x="7077075" y="942638"/>
                  <a:ext cx="2358660" cy="181312"/>
                </a:xfrm>
                <a:prstGeom prst="roundRect">
                  <a:avLst/>
                </a:prstGeom>
                <a:solidFill>
                  <a:srgbClr val="92D050"/>
                </a:solidFill>
                <a:ln>
                  <a:solidFill>
                    <a:srgbClr val="92D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8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>
                <a:xfrm>
                  <a:off x="7200901" y="904538"/>
                  <a:ext cx="2096850" cy="2224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VP2ep</a:t>
                  </a:r>
                  <a:endParaRPr lang="en-US" sz="8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7" name="TextBox 16"/>
              <p:cNvSpPr txBox="1"/>
              <p:nvPr/>
            </p:nvSpPr>
            <p:spPr>
              <a:xfrm>
                <a:off x="7651444" y="2035095"/>
                <a:ext cx="4680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Mlu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9467250" y="2038302"/>
                <a:ext cx="51601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Xma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" name="Straight Arrow Connector 18"/>
              <p:cNvCxnSpPr/>
              <p:nvPr/>
            </p:nvCxnSpPr>
            <p:spPr>
              <a:xfrm flipV="1">
                <a:off x="3972161" y="2634349"/>
                <a:ext cx="257174" cy="2"/>
              </a:xfrm>
              <a:prstGeom prst="straightConnector1">
                <a:avLst/>
              </a:prstGeom>
              <a:ln w="19050">
                <a:solidFill>
                  <a:srgbClr val="FF99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Arrow Connector 19"/>
              <p:cNvCxnSpPr/>
              <p:nvPr/>
            </p:nvCxnSpPr>
            <p:spPr>
              <a:xfrm flipH="1">
                <a:off x="7220186" y="2744351"/>
                <a:ext cx="320258" cy="1"/>
              </a:xfrm>
              <a:prstGeom prst="straightConnector1">
                <a:avLst/>
              </a:prstGeom>
              <a:ln w="19050">
                <a:solidFill>
                  <a:srgbClr val="FF99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Rounded Rectangle 20"/>
              <p:cNvSpPr/>
              <p:nvPr/>
            </p:nvSpPr>
            <p:spPr>
              <a:xfrm>
                <a:off x="7540444" y="2377131"/>
                <a:ext cx="327441" cy="175598"/>
              </a:xfrm>
              <a:prstGeom prst="roundRect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ounded Rectangle 21"/>
              <p:cNvSpPr/>
              <p:nvPr/>
            </p:nvSpPr>
            <p:spPr>
              <a:xfrm>
                <a:off x="3972161" y="2377131"/>
                <a:ext cx="3568284" cy="175598"/>
              </a:xfrm>
              <a:prstGeom prst="roundRect">
                <a:avLst/>
              </a:prstGeom>
              <a:solidFill>
                <a:srgbClr val="FF99FF"/>
              </a:solidFill>
              <a:ln>
                <a:solidFill>
                  <a:srgbClr val="FF99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8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6894456" y="2347991"/>
                <a:ext cx="16512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linker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4967880" y="2336994"/>
                <a:ext cx="165120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Zera</a:t>
                </a:r>
                <a:r>
                  <a:rPr lang="en-GB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®</a:t>
                </a:r>
                <a:endParaRPr lang="en-US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7540443" y="2744351"/>
                <a:ext cx="327441" cy="0"/>
              </a:xfrm>
              <a:prstGeom prst="line">
                <a:avLst/>
              </a:prstGeom>
              <a:ln w="190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>
                <a:off x="7540443" y="2877701"/>
                <a:ext cx="327441" cy="0"/>
              </a:xfrm>
              <a:prstGeom prst="line">
                <a:avLst/>
              </a:prstGeom>
              <a:ln w="19050">
                <a:solidFill>
                  <a:srgbClr val="00B0F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/>
              <p:cNvCxnSpPr/>
              <p:nvPr/>
            </p:nvCxnSpPr>
            <p:spPr>
              <a:xfrm>
                <a:off x="7867884" y="2877700"/>
                <a:ext cx="320258" cy="0"/>
              </a:xfrm>
              <a:prstGeom prst="straightConnector1">
                <a:avLst/>
              </a:prstGeom>
              <a:ln w="19050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Arrow Connector 27"/>
              <p:cNvCxnSpPr/>
              <p:nvPr/>
            </p:nvCxnSpPr>
            <p:spPr>
              <a:xfrm flipH="1">
                <a:off x="9405002" y="2877700"/>
                <a:ext cx="320258" cy="1"/>
              </a:xfrm>
              <a:prstGeom prst="straightConnector1">
                <a:avLst/>
              </a:prstGeom>
              <a:ln w="19050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 flipV="1">
                <a:off x="7542784" y="2252707"/>
                <a:ext cx="0" cy="12442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/>
              <p:cNvCxnSpPr/>
              <p:nvPr/>
            </p:nvCxnSpPr>
            <p:spPr>
              <a:xfrm flipV="1">
                <a:off x="7867884" y="2252707"/>
                <a:ext cx="0" cy="12442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V="1">
                <a:off x="9725260" y="2252707"/>
                <a:ext cx="0" cy="12442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V="1">
                <a:off x="3972161" y="2252707"/>
                <a:ext cx="0" cy="124424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TextBox 32"/>
              <p:cNvSpPr txBox="1"/>
              <p:nvPr/>
            </p:nvSpPr>
            <p:spPr>
              <a:xfrm>
                <a:off x="7306401" y="2035095"/>
                <a:ext cx="4680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Nco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3738119" y="2035095"/>
                <a:ext cx="46808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sz="800" i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ge</a:t>
                </a:r>
                <a:r>
                  <a:rPr lang="en-GB" sz="8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1792306" y="2023714"/>
              <a:ext cx="672863" cy="901359"/>
              <a:chOff x="1792306" y="2023714"/>
              <a:chExt cx="672863" cy="901359"/>
            </a:xfrm>
          </p:grpSpPr>
          <p:cxnSp>
            <p:nvCxnSpPr>
              <p:cNvPr id="8" name="Straight Arrow Connector 7"/>
              <p:cNvCxnSpPr/>
              <p:nvPr/>
            </p:nvCxnSpPr>
            <p:spPr>
              <a:xfrm flipV="1">
                <a:off x="1981918" y="2023714"/>
                <a:ext cx="257174" cy="2"/>
              </a:xfrm>
              <a:prstGeom prst="straightConnector1">
                <a:avLst/>
              </a:prstGeom>
              <a:ln w="19050">
                <a:solidFill>
                  <a:srgbClr val="FF99FF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9" name="Group 8"/>
              <p:cNvGrpSpPr/>
              <p:nvPr/>
            </p:nvGrpSpPr>
            <p:grpSpPr>
              <a:xfrm>
                <a:off x="1817471" y="2307415"/>
                <a:ext cx="647698" cy="1"/>
                <a:chOff x="1785487" y="2336994"/>
                <a:chExt cx="647698" cy="1"/>
              </a:xfrm>
            </p:grpSpPr>
            <p:cxnSp>
              <p:nvCxnSpPr>
                <p:cNvPr id="14" name="Straight Arrow Connector 13"/>
                <p:cNvCxnSpPr/>
                <p:nvPr/>
              </p:nvCxnSpPr>
              <p:spPr>
                <a:xfrm flipH="1">
                  <a:off x="1785487" y="2336994"/>
                  <a:ext cx="320258" cy="1"/>
                </a:xfrm>
                <a:prstGeom prst="straightConnector1">
                  <a:avLst/>
                </a:prstGeom>
                <a:ln w="19050">
                  <a:solidFill>
                    <a:srgbClr val="FF99FF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2105744" y="2336994"/>
                  <a:ext cx="327441" cy="0"/>
                </a:xfrm>
                <a:prstGeom prst="line">
                  <a:avLst/>
                </a:prstGeom>
                <a:ln w="1905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0" name="Group 9"/>
              <p:cNvGrpSpPr/>
              <p:nvPr/>
            </p:nvGrpSpPr>
            <p:grpSpPr>
              <a:xfrm>
                <a:off x="1792306" y="2616244"/>
                <a:ext cx="647699" cy="1"/>
                <a:chOff x="1778303" y="2689418"/>
                <a:chExt cx="647699" cy="1"/>
              </a:xfrm>
            </p:grpSpPr>
            <p:cxnSp>
              <p:nvCxnSpPr>
                <p:cNvPr id="12" name="Straight Connector 11"/>
                <p:cNvCxnSpPr/>
                <p:nvPr/>
              </p:nvCxnSpPr>
              <p:spPr>
                <a:xfrm>
                  <a:off x="1778303" y="2689419"/>
                  <a:ext cx="327441" cy="0"/>
                </a:xfrm>
                <a:prstGeom prst="line">
                  <a:avLst/>
                </a:prstGeom>
                <a:ln w="19050">
                  <a:solidFill>
                    <a:srgbClr val="00B0F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Arrow Connector 12"/>
                <p:cNvCxnSpPr/>
                <p:nvPr/>
              </p:nvCxnSpPr>
              <p:spPr>
                <a:xfrm>
                  <a:off x="2105744" y="2689418"/>
                  <a:ext cx="320258" cy="0"/>
                </a:xfrm>
                <a:prstGeom prst="straightConnector1">
                  <a:avLst/>
                </a:prstGeom>
                <a:ln w="19050">
                  <a:solidFill>
                    <a:srgbClr val="92D05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1" name="Straight Arrow Connector 10"/>
              <p:cNvCxnSpPr/>
              <p:nvPr/>
            </p:nvCxnSpPr>
            <p:spPr>
              <a:xfrm flipH="1">
                <a:off x="1963746" y="2925072"/>
                <a:ext cx="320258" cy="1"/>
              </a:xfrm>
              <a:prstGeom prst="straightConnector1">
                <a:avLst/>
              </a:prstGeom>
              <a:ln w="19050">
                <a:solidFill>
                  <a:srgbClr val="92D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/>
            <p:cNvSpPr txBox="1"/>
            <p:nvPr/>
          </p:nvSpPr>
          <p:spPr>
            <a:xfrm>
              <a:off x="2537513" y="1416343"/>
              <a:ext cx="1164101" cy="1938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ZA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imer name</a:t>
              </a:r>
            </a:p>
            <a:p>
              <a:endParaRPr lang="en-Z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Zera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®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P</a:t>
              </a:r>
            </a:p>
            <a:p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inker-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Zera</a:t>
              </a:r>
              <a:r>
                <a:rPr lang="en-GB" sz="10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®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RP</a:t>
              </a:r>
            </a:p>
            <a:p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inker-VP2ep-FP</a:t>
              </a:r>
            </a:p>
            <a:p>
              <a:endParaRPr lang="en-US" sz="10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P2ep-RP</a:t>
              </a:r>
            </a:p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en-ZA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33451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0</Words>
  <Application>Microsoft Office PowerPoint</Application>
  <PresentationFormat>On-screen Show (4:3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2</cp:revision>
  <dcterms:created xsi:type="dcterms:W3CDTF">2017-04-13T13:50:57Z</dcterms:created>
  <dcterms:modified xsi:type="dcterms:W3CDTF">2017-04-13T13:53:52Z</dcterms:modified>
</cp:coreProperties>
</file>